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19925" cy="93059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20000" cy="930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6200" y="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33480"/>
                <a:tab algn="l" pos="1866960"/>
                <a:tab algn="l" pos="2800440"/>
                <a:tab algn="l" pos="3733920"/>
                <a:tab algn="l" pos="4667400"/>
                <a:tab algn="l" pos="5600880"/>
                <a:tab algn="l" pos="6534000"/>
                <a:tab algn="l" pos="7467480"/>
                <a:tab algn="l" pos="8400960"/>
                <a:tab algn="l" pos="9334440"/>
                <a:tab algn="l" pos="1026792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33480"/>
                <a:tab algn="l" pos="1866960"/>
                <a:tab algn="l" pos="2800440"/>
                <a:tab algn="l" pos="3733920"/>
                <a:tab algn="l" pos="4667400"/>
                <a:tab algn="l" pos="5600880"/>
                <a:tab algn="l" pos="6534000"/>
                <a:tab algn="l" pos="7467480"/>
                <a:tab algn="l" pos="8400960"/>
                <a:tab algn="l" pos="9334440"/>
                <a:tab algn="l" pos="102679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4040" y="698040"/>
            <a:ext cx="4653000" cy="3489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640" y="4419360"/>
            <a:ext cx="5616720" cy="41878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620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33480"/>
                <a:tab algn="l" pos="1866960"/>
                <a:tab algn="l" pos="2800440"/>
                <a:tab algn="l" pos="3733920"/>
                <a:tab algn="l" pos="4667400"/>
                <a:tab algn="l" pos="5600880"/>
                <a:tab algn="l" pos="6534000"/>
                <a:tab algn="l" pos="7467480"/>
                <a:tab algn="l" pos="8400960"/>
                <a:tab algn="l" pos="9334440"/>
                <a:tab algn="l" pos="1026792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33480"/>
                <a:tab algn="l" pos="1866960"/>
                <a:tab algn="l" pos="2800440"/>
                <a:tab algn="l" pos="3733920"/>
                <a:tab algn="l" pos="4667400"/>
                <a:tab algn="l" pos="5600880"/>
                <a:tab algn="l" pos="6534000"/>
                <a:tab algn="l" pos="7467480"/>
                <a:tab algn="l" pos="8400960"/>
                <a:tab algn="l" pos="9334440"/>
                <a:tab algn="l" pos="10267920"/>
              </a:tabLst>
            </a:pPr>
            <a:fld id="{18D07864-F0BB-4B20-9E82-19F69654673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84400" y="698400"/>
            <a:ext cx="4653000" cy="348948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701640" y="4419360"/>
            <a:ext cx="5616720" cy="418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97656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800" bIns="46800" anchor="b">
            <a:noAutofit/>
          </a:bodyPr>
          <a:p>
            <a:pPr algn="r">
              <a:tabLst>
                <a:tab algn="l" pos="0"/>
                <a:tab algn="l" pos="933480"/>
                <a:tab algn="l" pos="1866960"/>
                <a:tab algn="l" pos="2800440"/>
                <a:tab algn="l" pos="3733920"/>
                <a:tab algn="l" pos="4667400"/>
                <a:tab algn="l" pos="5600880"/>
                <a:tab algn="l" pos="6534000"/>
                <a:tab algn="l" pos="7467480"/>
                <a:tab algn="l" pos="8400960"/>
                <a:tab algn="l" pos="9334440"/>
                <a:tab algn="l" pos="10267920"/>
              </a:tabLst>
            </a:pPr>
            <a:fld id="{D097A90E-BE78-4D50-872A-744BF486FEA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8F93C-23DA-410C-99D7-04CE336263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891B6-BBC6-4F42-BFB7-A4E25227BA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09704-2A6E-4788-B921-A526B261E1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96B26F-2F98-4A7B-A1D0-38E84FE040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C6A04-A0BB-4995-8D26-4C4CBDF40F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FE2CB-68B5-4EE3-ACEE-62AF129E63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77D04-DF7B-4757-BF47-EA91FC26D4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29976-A45D-4BB3-A9F6-DA56FCE86C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96206-2625-4633-91D9-7AEAFBD676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3A3B1-5A43-4B3C-A750-49F475455D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A6987-0FBD-42D9-BB33-FC40955B75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1F1B5-5AFF-420C-BE8B-A62D15DD17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98ECDA-6217-46B1-A37B-D5A329DA46B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2604960" y="2087640"/>
            <a:ext cx="3934080" cy="32464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1777680" y="533520"/>
            <a:ext cx="5302800" cy="10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4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Genome origin of BAC 0006M07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NAs were amplified using primers AF3 (GCATTCAGTGTTATTTGCCAATGT) and R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TTCATGGTGGAGCAGTACCATATC). (M) = markers. (A) Chinese Spring nulli6A-tetra6D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B) Chinese Spring null6B-tetra6D. (C) BAC 0006M07. (D) Tetraploid cultivar Langd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AB genomes). Arrowhead indicates predicted position of PCR fragment using primers AF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d R3. B- and D-genome specific primers did not amplify from the BAC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20:23:06Z</dcterms:created>
  <dc:creator> </dc:creator>
  <dc:description/>
  <dc:language>en-US</dc:language>
  <cp:lastModifiedBy>Office 2003 Registered User</cp:lastModifiedBy>
  <dcterms:modified xsi:type="dcterms:W3CDTF">2010-05-18T23:06:22Z</dcterms:modified>
  <cp:revision>3</cp:revision>
  <dc:subject/>
  <dc:title>Slide 1</dc:title>
</cp:coreProperties>
</file>